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howGuides="1"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001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16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133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6278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2901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7192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569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744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443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22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621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73287-30C6-4B2C-993A-AAC50274A59B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D4BDF-1E61-461E-A45B-6E81C91F7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595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26" Type="http://schemas.openxmlformats.org/officeDocument/2006/relationships/image" Target="../media/image25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34" Type="http://schemas.openxmlformats.org/officeDocument/2006/relationships/image" Target="../media/image33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33" Type="http://schemas.openxmlformats.org/officeDocument/2006/relationships/image" Target="../media/image32.emf"/><Relationship Id="rId38" Type="http://schemas.openxmlformats.org/officeDocument/2006/relationships/image" Target="../media/image37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emf"/><Relationship Id="rId32" Type="http://schemas.openxmlformats.org/officeDocument/2006/relationships/image" Target="../media/image31.emf"/><Relationship Id="rId37" Type="http://schemas.openxmlformats.org/officeDocument/2006/relationships/image" Target="../media/image36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31" Type="http://schemas.openxmlformats.org/officeDocument/2006/relationships/image" Target="../media/image30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Relationship Id="rId27" Type="http://schemas.openxmlformats.org/officeDocument/2006/relationships/image" Target="../media/image26.emf"/><Relationship Id="rId30" Type="http://schemas.openxmlformats.org/officeDocument/2006/relationships/image" Target="../media/image29.emf"/><Relationship Id="rId35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17" y="914882"/>
            <a:ext cx="259441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042" y="962503"/>
            <a:ext cx="259441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5455" y="2471645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38128" y="2471798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47"/>
          <p:cNvSpPr txBox="1">
            <a:spLocks noChangeArrowheads="1"/>
          </p:cNvSpPr>
          <p:nvPr/>
        </p:nvSpPr>
        <p:spPr bwMode="auto">
          <a:xfrm rot="16200000">
            <a:off x="-179520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9" name="TextBox 47"/>
          <p:cNvSpPr txBox="1">
            <a:spLocks noChangeArrowheads="1"/>
          </p:cNvSpPr>
          <p:nvPr/>
        </p:nvSpPr>
        <p:spPr bwMode="auto">
          <a:xfrm rot="16200000">
            <a:off x="3038726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75671" y="100704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A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852481" y="100704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GB" sz="12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782614" y="-76810"/>
            <a:ext cx="3361722" cy="1099606"/>
            <a:chOff x="802845" y="-150673"/>
            <a:chExt cx="3361722" cy="1099606"/>
          </a:xfrm>
        </p:grpSpPr>
        <p:sp>
          <p:nvSpPr>
            <p:cNvPr id="13" name="TextBox 12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ERK</a:t>
              </a:r>
              <a:endParaRPr lang="en-GB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6156998" y="1122195"/>
            <a:ext cx="730215" cy="384578"/>
            <a:chOff x="6156998" y="1122195"/>
            <a:chExt cx="730215" cy="384578"/>
          </a:xfrm>
        </p:grpSpPr>
        <p:sp>
          <p:nvSpPr>
            <p:cNvPr id="23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24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25" name="Straight Connector 24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166"/>
          <p:cNvSpPr txBox="1">
            <a:spLocks noChangeArrowheads="1"/>
          </p:cNvSpPr>
          <p:nvPr/>
        </p:nvSpPr>
        <p:spPr bwMode="auto">
          <a:xfrm>
            <a:off x="4030287" y="1312906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pic>
        <p:nvPicPr>
          <p:cNvPr id="28" name="Picture 79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7543" y="8436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80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2499" y="83749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81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8114" y="83749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82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2069" y="83749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83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0460" y="83749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84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2644" y="8436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85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6379" y="8436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86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488" y="8436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6" name="Group 35"/>
          <p:cNvGrpSpPr/>
          <p:nvPr/>
        </p:nvGrpSpPr>
        <p:grpSpPr>
          <a:xfrm>
            <a:off x="3958695" y="-92607"/>
            <a:ext cx="3435560" cy="1111631"/>
            <a:chOff x="3914896" y="-135184"/>
            <a:chExt cx="3435560" cy="1111631"/>
          </a:xfrm>
        </p:grpSpPr>
        <p:sp>
          <p:nvSpPr>
            <p:cNvPr id="37" name="TextBox 36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ERK</a:t>
              </a:r>
              <a:endParaRPr lang="en-GB" sz="1200" dirty="0"/>
            </a:p>
          </p:txBody>
        </p:sp>
        <p:sp>
          <p:nvSpPr>
            <p:cNvPr id="39" name="TextBox 38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40" name="TextBox 39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46" name="Picture 69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1903" y="855446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70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4336" y="852949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71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0727" y="85274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72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4206" y="85853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73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2460" y="85274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Picture 75"/>
          <p:cNvPicPr preferRelativeResize="0"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3492" y="85853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" name="Picture 76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8725" y="85599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" name="Picture 77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7765" y="85853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735884" y="1020728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Dorsal Hippocampus</a:t>
            </a:r>
            <a:endParaRPr lang="en-US" sz="1000" dirty="0"/>
          </a:p>
        </p:txBody>
      </p:sp>
      <p:sp>
        <p:nvSpPr>
          <p:cNvPr id="55" name="TextBox 54"/>
          <p:cNvSpPr txBox="1"/>
          <p:nvPr/>
        </p:nvSpPr>
        <p:spPr>
          <a:xfrm>
            <a:off x="4001889" y="1029580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Dorsal Hippocampus</a:t>
            </a:r>
            <a:endParaRPr lang="en-US" sz="1000" dirty="0"/>
          </a:p>
        </p:txBody>
      </p:sp>
      <p:pic>
        <p:nvPicPr>
          <p:cNvPr id="56" name="Picture 55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674" y="3481705"/>
            <a:ext cx="2315183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7" name="Picture 56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78" y="3484165"/>
            <a:ext cx="2423652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5455" y="4993307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9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38128" y="4993460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0" name="TextBox 47"/>
          <p:cNvSpPr txBox="1">
            <a:spLocks noChangeArrowheads="1"/>
          </p:cNvSpPr>
          <p:nvPr/>
        </p:nvSpPr>
        <p:spPr bwMode="auto">
          <a:xfrm rot="16200000">
            <a:off x="-179520" y="39447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1" name="TextBox 47"/>
          <p:cNvSpPr txBox="1">
            <a:spLocks noChangeArrowheads="1"/>
          </p:cNvSpPr>
          <p:nvPr/>
        </p:nvSpPr>
        <p:spPr bwMode="auto">
          <a:xfrm rot="16200000">
            <a:off x="3038726" y="39447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75671" y="346386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C</a:t>
            </a:r>
            <a:endParaRPr lang="en-GB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3829904" y="342543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</a:t>
            </a:r>
            <a:endParaRPr lang="en-GB" sz="1200" dirty="0"/>
          </a:p>
        </p:txBody>
      </p:sp>
      <p:grpSp>
        <p:nvGrpSpPr>
          <p:cNvPr id="64" name="Group 63"/>
          <p:cNvGrpSpPr/>
          <p:nvPr/>
        </p:nvGrpSpPr>
        <p:grpSpPr>
          <a:xfrm>
            <a:off x="782614" y="2444852"/>
            <a:ext cx="3361722" cy="1099606"/>
            <a:chOff x="802845" y="-150673"/>
            <a:chExt cx="3361722" cy="1099606"/>
          </a:xfrm>
        </p:grpSpPr>
        <p:sp>
          <p:nvSpPr>
            <p:cNvPr id="65" name="TextBox 64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69" name="TextBox 68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72" name="TextBox 71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p38</a:t>
              </a:r>
              <a:endParaRPr lang="en-GB" sz="1200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6156998" y="3643857"/>
            <a:ext cx="730215" cy="384578"/>
            <a:chOff x="6156998" y="1122195"/>
            <a:chExt cx="730215" cy="384578"/>
          </a:xfrm>
        </p:grpSpPr>
        <p:sp>
          <p:nvSpPr>
            <p:cNvPr id="75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76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77" name="Straight Connector 76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Box 166"/>
          <p:cNvSpPr txBox="1">
            <a:spLocks noChangeArrowheads="1"/>
          </p:cNvSpPr>
          <p:nvPr/>
        </p:nvSpPr>
        <p:spPr bwMode="auto">
          <a:xfrm>
            <a:off x="4044294" y="3834568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pic>
        <p:nvPicPr>
          <p:cNvPr id="80" name="Picture 13"/>
          <p:cNvPicPr preferRelativeResize="0"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619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" name="Picture 14"/>
          <p:cNvPicPr preferRelativeResize="0">
            <a:picLocks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9556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2" name="Picture 19"/>
          <p:cNvPicPr preferRelativeResize="0"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2069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20"/>
          <p:cNvPicPr preferRelativeResize="0">
            <a:picLocks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6379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4" name="Picture 21"/>
          <p:cNvPicPr preferRelativeResize="0">
            <a:picLocks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2825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22"/>
          <p:cNvPicPr preferRelativeResize="0"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189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23"/>
          <p:cNvPicPr preferRelativeResize="0">
            <a:picLocks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2655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24"/>
          <p:cNvPicPr preferRelativeResize="0">
            <a:picLocks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9190" y="338748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8" name="Group 87"/>
          <p:cNvGrpSpPr/>
          <p:nvPr/>
        </p:nvGrpSpPr>
        <p:grpSpPr>
          <a:xfrm>
            <a:off x="3958695" y="2429055"/>
            <a:ext cx="3435560" cy="1111631"/>
            <a:chOff x="3914896" y="-135184"/>
            <a:chExt cx="3435560" cy="1111631"/>
          </a:xfrm>
        </p:grpSpPr>
        <p:sp>
          <p:nvSpPr>
            <p:cNvPr id="89" name="TextBox 88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smtClean="0"/>
                <a:t>Phosphop38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92" name="TextBox 91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93" name="TextBox 92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94" name="TextBox 93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98" name="Picture 3"/>
          <p:cNvPicPr preferRelativeResize="0"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3834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9" name="Picture 5"/>
          <p:cNvPicPr preferRelativeResize="0"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6666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0" name="Picture 7"/>
          <p:cNvPicPr preferRelativeResize="0">
            <a:picLocks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2330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1" name="Picture 10"/>
          <p:cNvPicPr preferRelativeResize="0">
            <a:picLocks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0825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" name="Picture 15"/>
          <p:cNvPicPr preferRelativeResize="0">
            <a:picLocks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5162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16"/>
          <p:cNvPicPr preferRelativeResize="0">
            <a:picLocks noChangeArrowheads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7994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17"/>
          <p:cNvPicPr preferRelativeResize="0"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9498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" name="Picture 18"/>
          <p:cNvPicPr preferRelativeResize="0">
            <a:picLocks noChangeArrowheads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1002" y="33628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6" name="TextBox 105"/>
          <p:cNvSpPr txBox="1"/>
          <p:nvPr/>
        </p:nvSpPr>
        <p:spPr>
          <a:xfrm>
            <a:off x="716042" y="3492448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Dorsal Hippocampus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>
            <a:off x="3951795" y="3447349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Dorsal Hippocampus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290161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28</Words>
  <Application>Microsoft Office PowerPoint</Application>
  <PresentationFormat>On-screen Show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yola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pinceti</dc:creator>
  <cp:lastModifiedBy>Elpinceti</cp:lastModifiedBy>
  <cp:revision>4</cp:revision>
  <dcterms:created xsi:type="dcterms:W3CDTF">2016-04-22T00:15:24Z</dcterms:created>
  <dcterms:modified xsi:type="dcterms:W3CDTF">2016-05-23T16:29:34Z</dcterms:modified>
</cp:coreProperties>
</file>